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943" autoAdjust="0"/>
  </p:normalViewPr>
  <p:slideViewPr>
    <p:cSldViewPr>
      <p:cViewPr varScale="1">
        <p:scale>
          <a:sx n="103" d="100"/>
          <a:sy n="103" d="100"/>
        </p:scale>
        <p:origin x="-27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DAF58-3925-4E6C-A980-945DEA4E71C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6549-5E2E-4D9C-820F-0446AB0EAD2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1373981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DAF58-3925-4E6C-A980-945DEA4E71C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6549-5E2E-4D9C-820F-0446AB0EAD2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721630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DAF58-3925-4E6C-A980-945DEA4E71C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6549-5E2E-4D9C-820F-0446AB0EAD2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951871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DAF58-3925-4E6C-A980-945DEA4E71C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6549-5E2E-4D9C-820F-0446AB0EAD2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100874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DAF58-3925-4E6C-A980-945DEA4E71C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6549-5E2E-4D9C-820F-0446AB0EAD2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9176865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DAF58-3925-4E6C-A980-945DEA4E71C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6549-5E2E-4D9C-820F-0446AB0EAD2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279911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DAF58-3925-4E6C-A980-945DEA4E71C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6549-5E2E-4D9C-820F-0446AB0EAD2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5252972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DAF58-3925-4E6C-A980-945DEA4E71C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6549-5E2E-4D9C-820F-0446AB0EAD2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6685888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DAF58-3925-4E6C-A980-945DEA4E71C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6549-5E2E-4D9C-820F-0446AB0EAD2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0380223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DAF58-3925-4E6C-A980-945DEA4E71C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6549-5E2E-4D9C-820F-0446AB0EAD2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9808087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DAF58-3925-4E6C-A980-945DEA4E71C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6549-5E2E-4D9C-820F-0446AB0EAD2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566643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ADAF58-3925-4E6C-A980-945DEA4E71C1}" type="datetimeFigureOut">
              <a:rPr lang="de-AT" smtClean="0"/>
              <a:t>19.10.2016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7C6549-5E2E-4D9C-820F-0446AB0EAD2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4043076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jpe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itle 1"/>
          <p:cNvSpPr>
            <a:spLocks noGrp="1"/>
          </p:cNvSpPr>
          <p:nvPr>
            <p:ph type="ctrTitle"/>
          </p:nvPr>
        </p:nvSpPr>
        <p:spPr>
          <a:xfrm>
            <a:off x="-23192" y="-31358"/>
            <a:ext cx="7043464" cy="436022"/>
          </a:xfrm>
        </p:spPr>
        <p:txBody>
          <a:bodyPr>
            <a:normAutofit/>
          </a:bodyPr>
          <a:lstStyle/>
          <a:p>
            <a:pPr algn="l"/>
            <a:r>
              <a:rPr lang="de-AT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4: </a:t>
            </a:r>
            <a:r>
              <a:rPr lang="de-AT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de-AT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r>
              <a:rPr lang="de-AT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Stress conditions affect induced differentiation of MSCs.  </a:t>
            </a:r>
            <a:endParaRPr lang="de-AT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565286" y="325645"/>
            <a:ext cx="5806399" cy="5565062"/>
            <a:chOff x="1440158" y="565961"/>
            <a:chExt cx="5806399" cy="5565062"/>
          </a:xfrm>
        </p:grpSpPr>
        <p:sp>
          <p:nvSpPr>
            <p:cNvPr id="4" name="TextBox 3"/>
            <p:cNvSpPr txBox="1"/>
            <p:nvPr/>
          </p:nvSpPr>
          <p:spPr>
            <a:xfrm>
              <a:off x="1440160" y="1314202"/>
              <a:ext cx="8899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rmoxia</a:t>
              </a:r>
              <a:endParaRPr lang="de-AT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330143" y="565961"/>
              <a:ext cx="491641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dirty="0">
                  <a:solidFill>
                    <a:prstClr val="black"/>
                  </a:solidFill>
                </a:rPr>
                <a:t>           </a:t>
              </a:r>
              <a:r>
                <a:rPr lang="de-AT" sz="12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dipocyte</a:t>
              </a:r>
              <a:r>
                <a:rPr lang="de-AT" sz="12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de-AT" sz="12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   </a:t>
              </a:r>
              <a:r>
                <a:rPr lang="de-AT" sz="12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steocytes</a:t>
              </a:r>
              <a:r>
                <a:rPr lang="de-AT" sz="12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    </a:t>
              </a:r>
              <a:r>
                <a:rPr lang="de-AT" sz="1200" dirty="0" err="1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ondrocyte</a:t>
              </a:r>
              <a:r>
                <a:rPr lang="de-AT" sz="12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de-AT" sz="120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</a:t>
              </a:r>
              <a:endParaRPr lang="de-AT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440158" y="2730201"/>
              <a:ext cx="9769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arvation</a:t>
              </a:r>
              <a:endParaRPr lang="de-AT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67944" y="938393"/>
              <a:ext cx="1519574" cy="12132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67943" y="2269837"/>
              <a:ext cx="1519575" cy="12156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17079" y="938393"/>
              <a:ext cx="1516826" cy="12132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53" name="Picture 5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17079" y="2260873"/>
              <a:ext cx="1522546" cy="12156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54" name="Picture 6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24128" y="935293"/>
              <a:ext cx="1522429" cy="12150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55" name="Picture 7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24128" y="2290507"/>
              <a:ext cx="1519572" cy="12156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" name="TextBox 11"/>
            <p:cNvSpPr txBox="1"/>
            <p:nvPr/>
          </p:nvSpPr>
          <p:spPr>
            <a:xfrm>
              <a:off x="1544538" y="4031638"/>
              <a:ext cx="7681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ypoxia</a:t>
              </a:r>
              <a:endParaRPr lang="de-AT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440160" y="5298047"/>
              <a:ext cx="95446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2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ypoxia</a:t>
              </a:r>
              <a:r>
                <a:rPr lang="de-AT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</a:p>
            <a:p>
              <a:r>
                <a:rPr lang="de-AT" sz="12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arvation</a:t>
              </a:r>
              <a:endParaRPr lang="de-AT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" name="Picture 3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67943" y="3565685"/>
              <a:ext cx="1519575" cy="12090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" name="Picture 4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67943" y="4934614"/>
              <a:ext cx="1519575" cy="11964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" name="Picture 5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22772" y="3565685"/>
              <a:ext cx="1511133" cy="12089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8" name="Picture 6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22771" y="4934614"/>
              <a:ext cx="1516853" cy="11885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9" name="Picture 7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24127" y="4934614"/>
              <a:ext cx="1522429" cy="11885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" name="Picture 8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24128" y="3565685"/>
              <a:ext cx="1519572" cy="12156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22" name="Content Placeholder 2"/>
          <p:cNvSpPr txBox="1">
            <a:spLocks/>
          </p:cNvSpPr>
          <p:nvPr/>
        </p:nvSpPr>
        <p:spPr>
          <a:xfrm>
            <a:off x="107504" y="6009703"/>
            <a:ext cx="8928992" cy="84829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2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Legend. </a:t>
            </a:r>
            <a:r>
              <a:rPr lang="en-US" sz="12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Cs were cultured under stress conditions (hypoxia, starvation and their combination) for 11 days to achieve visible morphological changes of cells and then </a:t>
            </a:r>
            <a:r>
              <a:rPr lang="en-US" sz="12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ipogenic</a:t>
            </a:r>
            <a:r>
              <a:rPr lang="en-US" sz="12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steogenic</a:t>
            </a:r>
            <a:r>
              <a:rPr lang="en-US" sz="12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ndrogenic</a:t>
            </a:r>
            <a:r>
              <a:rPr lang="en-US" sz="12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ifferentiation was induced with the appropriate mediums. After further 14 days specific </a:t>
            </a:r>
            <a:r>
              <a:rPr lang="en-US" sz="12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inings</a:t>
            </a:r>
            <a:r>
              <a:rPr lang="en-US" sz="12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ith Oil Red O, Alizarin Red S and </a:t>
            </a:r>
            <a:r>
              <a:rPr lang="en-US" sz="12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luidin</a:t>
            </a:r>
            <a:r>
              <a:rPr lang="en-US" sz="12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Blue, respectively, were performed. </a:t>
            </a:r>
            <a:endParaRPr lang="de-AT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57584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Additional file 4: Figure S4. Stress conditions affect induced differentiation of MSCs.  </vt:lpstr>
    </vt:vector>
  </TitlesOfParts>
  <Company>stan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2</dc:title>
  <dc:creator>Husak Zvenyslava</dc:creator>
  <cp:lastModifiedBy>Husak Zvenyslava</cp:lastModifiedBy>
  <cp:revision>9</cp:revision>
  <dcterms:created xsi:type="dcterms:W3CDTF">2014-06-23T12:26:04Z</dcterms:created>
  <dcterms:modified xsi:type="dcterms:W3CDTF">2016-10-19T11:56:50Z</dcterms:modified>
</cp:coreProperties>
</file>